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006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73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BA0B0FB-E4A9-EE45-FCB7-F2CCA1167FD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332670C2-86FF-18E7-9FE0-35F18928A22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6612CF2-1680-0C3B-5B8C-2FF63364AB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F187A1-7AA7-4BDA-9503-6A03814CE636}" type="datetimeFigureOut">
              <a:rPr lang="ko-KR" altLang="en-US" smtClean="0"/>
              <a:t>2024-07-1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2E8D9AF-0976-7416-42C1-53F7B5CE92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7BDB451-F918-EF45-0EE2-BA9A000B64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835863-BE74-42CB-9BA1-EC365E90B4E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472943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2B19009-8DE7-33BF-D396-C545A6574D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02F78C7E-F0F1-D5AE-264C-71999AEE359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F47CA49-2975-59AD-E1B2-C5740022C1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F187A1-7AA7-4BDA-9503-6A03814CE636}" type="datetimeFigureOut">
              <a:rPr lang="ko-KR" altLang="en-US" smtClean="0"/>
              <a:t>2024-07-1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F1ADC66-BAC2-66D4-EE2A-682DB77C6B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1B927B5E-EB44-135D-A069-881FD57DF6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835863-BE74-42CB-9BA1-EC365E90B4E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912057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54689EDA-E5DA-19CA-B674-E93E51A5E6A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F416AA55-DF0C-4090-E43C-227256D094E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704E095-0478-763F-0698-0C7F381BF3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F187A1-7AA7-4BDA-9503-6A03814CE636}" type="datetimeFigureOut">
              <a:rPr lang="ko-KR" altLang="en-US" smtClean="0"/>
              <a:t>2024-07-1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0170D3E-2618-426C-9468-BC1DB93E63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C2B605E-BFB6-795C-9A32-6B47681026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835863-BE74-42CB-9BA1-EC365E90B4E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802637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5B8D878-97CF-F91A-2F19-1D2C935467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F7B36C4A-C5C4-854A-CEA5-3F4528F3B55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9F0D3C2-3BF1-6F4A-D76F-F89E46B52B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F187A1-7AA7-4BDA-9503-6A03814CE636}" type="datetimeFigureOut">
              <a:rPr lang="ko-KR" altLang="en-US" smtClean="0"/>
              <a:t>2024-07-1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295745C-BD84-6426-6FD0-ABE0E39819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1DB2769C-942E-51A2-65D3-F8A4C0E509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835863-BE74-42CB-9BA1-EC365E90B4E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817264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0AB8567-05A1-F0AB-EC77-0A7C421F01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36EA010B-184D-013A-C402-B93A4BFA24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0C8426E-CB7B-2ACD-9D86-DFAF618506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F187A1-7AA7-4BDA-9503-6A03814CE636}" type="datetimeFigureOut">
              <a:rPr lang="ko-KR" altLang="en-US" smtClean="0"/>
              <a:t>2024-07-1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77FC45F-3F68-6D96-0DA2-66891904C7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1AB9C5EA-5BE9-64BE-FB81-A8AB544BE6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835863-BE74-42CB-9BA1-EC365E90B4E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893786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2C38711-C3D1-2682-CF77-0BF4356010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F081409C-ACD3-DFB5-047B-7249BF8CEC2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8C81519E-B7A8-7792-2B4B-1D83385C50E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00553AFD-C061-5AE0-4A0C-110146327F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F187A1-7AA7-4BDA-9503-6A03814CE636}" type="datetimeFigureOut">
              <a:rPr lang="ko-KR" altLang="en-US" smtClean="0"/>
              <a:t>2024-07-11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62FA7291-69D2-A558-CC7F-9164DEA085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BADB5FBC-56FD-1CA2-9E1B-57146D59B0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835863-BE74-42CB-9BA1-EC365E90B4E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364362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ED88662-7E14-FFA1-F0D8-64AE7F9845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D01BB99E-0A2C-650E-C385-00DB8F75F8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5DEC7D2C-53E6-01B5-5F22-ABD1624593C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2F730D4D-AA20-45EB-9460-13CC9591E18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306238B6-21FD-F49E-A9AE-317EE80A7D6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DF981DFF-05B6-229D-C8CC-09AA6CDCA7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F187A1-7AA7-4BDA-9503-6A03814CE636}" type="datetimeFigureOut">
              <a:rPr lang="ko-KR" altLang="en-US" smtClean="0"/>
              <a:t>2024-07-11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9AB21F01-DF6D-4A41-AC00-1B5BB67AE6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3BDE2267-E1BF-F5A0-E688-A47D603B7A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835863-BE74-42CB-9BA1-EC365E90B4E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813796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C93809E-0B70-C786-B178-9AC8DA7CC7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3B1508C4-942C-51B5-83D8-D62D2ABBE5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F187A1-7AA7-4BDA-9503-6A03814CE636}" type="datetimeFigureOut">
              <a:rPr lang="ko-KR" altLang="en-US" smtClean="0"/>
              <a:t>2024-07-11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180A7572-FCED-E106-503C-A7F125D41F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00C32C40-7B8A-5037-BA37-09CEDE20F7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835863-BE74-42CB-9BA1-EC365E90B4E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609259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465D999C-D777-2D67-EE98-30FCD5F1E9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F187A1-7AA7-4BDA-9503-6A03814CE636}" type="datetimeFigureOut">
              <a:rPr lang="ko-KR" altLang="en-US" smtClean="0"/>
              <a:t>2024-07-11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276C16CA-88F3-8923-12DA-956A94489F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0F84CFB4-2DFD-A90B-FCFA-AF5B7BBCB8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835863-BE74-42CB-9BA1-EC365E90B4E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375904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79EDD4C-3DEC-78AE-BACC-439255A730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8CAFED32-304B-B9F0-7AFC-43C7139C871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D6F90255-3471-C219-67B6-AD76D7526EF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0482340F-7AD9-B792-586D-D97E4CF71C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F187A1-7AA7-4BDA-9503-6A03814CE636}" type="datetimeFigureOut">
              <a:rPr lang="ko-KR" altLang="en-US" smtClean="0"/>
              <a:t>2024-07-11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2D8F5038-1E75-2D52-03E5-AEA51D1DD6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92995677-8949-5456-1FF9-807E9E1710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835863-BE74-42CB-9BA1-EC365E90B4E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383685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30129AA-5595-24B3-307B-23A07A0BE8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80A8796A-37B6-7D4F-A2BF-EAAFFCF68FF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337B4521-BABF-01AF-6B04-85E8DEA8193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8AAA26C0-AAAE-702C-6D7C-21AD27C5FA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F187A1-7AA7-4BDA-9503-6A03814CE636}" type="datetimeFigureOut">
              <a:rPr lang="ko-KR" altLang="en-US" smtClean="0"/>
              <a:t>2024-07-11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2DF4BA80-3CFD-5638-CDF7-880F24AE62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2866F95F-860B-11A7-1CA0-09FF3BA67F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835863-BE74-42CB-9BA1-EC365E90B4E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306030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DF26B092-14F4-9ADC-366F-BC0B08E28B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169B8A58-1E80-20D1-1296-D3744E70673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883F265-9A9B-F39B-7B47-83BC3A2FAC0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F187A1-7AA7-4BDA-9503-6A03814CE636}" type="datetimeFigureOut">
              <a:rPr lang="ko-KR" altLang="en-US" smtClean="0"/>
              <a:t>2024-07-1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F3F47B8-8472-B307-1E74-2587C5F5460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E9704D6-DD6F-6FD2-6A84-F296FE8C807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835863-BE74-42CB-9BA1-EC365E90B4E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930994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35FF134-AE66-D5AA-5B36-C418809B6D7D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F2D9D898-88BA-507F-6A07-482C44929C60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ko-KR" altLang="en-US"/>
          </a:p>
        </p:txBody>
      </p:sp>
      <p:pic>
        <p:nvPicPr>
          <p:cNvPr id="5" name="그림 4">
            <a:extLst>
              <a:ext uri="{FF2B5EF4-FFF2-40B4-BE49-F238E27FC236}">
                <a16:creationId xmlns:a16="http://schemas.microsoft.com/office/drawing/2014/main" id="{BF6D7BE8-7E7D-052D-AD79-C409910EB38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8888" y="732846"/>
            <a:ext cx="10174224" cy="6059424"/>
          </a:xfrm>
          <a:prstGeom prst="rect">
            <a:avLst/>
          </a:prstGeom>
        </p:spPr>
      </p:pic>
      <p:sp>
        <p:nvSpPr>
          <p:cNvPr id="7" name="Rectangle 2">
            <a:extLst>
              <a:ext uri="{FF2B5EF4-FFF2-40B4-BE49-F238E27FC236}">
                <a16:creationId xmlns:a16="http://schemas.microsoft.com/office/drawing/2014/main" id="{5290FB63-A504-A934-5316-34805FCF449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5833" y="332994"/>
            <a:ext cx="5195653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함초롬바탕" panose="02030604000101010101" pitchFamily="18" charset="-127"/>
                <a:ea typeface="함초롬바탕" panose="02030604000101010101" pitchFamily="18" charset="-127"/>
              </a:rPr>
              <a:t>Figure S1. General information of the Chungcheong region</a:t>
            </a:r>
            <a:endParaRPr kumimoji="0" lang="en-US" altLang="ko-KR" sz="9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36115240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내용 개체 틀 4">
            <a:extLst>
              <a:ext uri="{FF2B5EF4-FFF2-40B4-BE49-F238E27FC236}">
                <a16:creationId xmlns:a16="http://schemas.microsoft.com/office/drawing/2014/main" id="{1A5DC740-F45B-0FED-1FF8-B254BA0F4F30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43659" y="1155900"/>
            <a:ext cx="6486144" cy="4322064"/>
          </a:xfrm>
        </p:spPr>
      </p:pic>
      <p:sp>
        <p:nvSpPr>
          <p:cNvPr id="7" name="Rectangle 2">
            <a:extLst>
              <a:ext uri="{FF2B5EF4-FFF2-40B4-BE49-F238E27FC236}">
                <a16:creationId xmlns:a16="http://schemas.microsoft.com/office/drawing/2014/main" id="{E1BD342C-F380-ADDA-C748-D39CF9ED427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5833" y="332994"/>
            <a:ext cx="5245347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함초롬바탕" panose="02030604000101010101" pitchFamily="18" charset="-127"/>
                <a:ea typeface="함초롬바탕" panose="02030604000101010101" pitchFamily="18" charset="-127"/>
              </a:rPr>
              <a:t>Figure S2. Population changes following region and years </a:t>
            </a:r>
            <a:endParaRPr kumimoji="0" lang="en-US" altLang="ko-KR" sz="9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304139574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내용 개체 틀 6">
            <a:extLst>
              <a:ext uri="{FF2B5EF4-FFF2-40B4-BE49-F238E27FC236}">
                <a16:creationId xmlns:a16="http://schemas.microsoft.com/office/drawing/2014/main" id="{5EA5A8A1-7332-F630-BF25-9109853D8CED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844166611"/>
              </p:ext>
            </p:extLst>
          </p:nvPr>
        </p:nvGraphicFramePr>
        <p:xfrm>
          <a:off x="366603" y="843150"/>
          <a:ext cx="9103744" cy="4437280"/>
        </p:xfrm>
        <a:graphic>
          <a:graphicData uri="http://schemas.openxmlformats.org/drawingml/2006/table">
            <a:tbl>
              <a:tblPr/>
              <a:tblGrid>
                <a:gridCol w="1066148">
                  <a:extLst>
                    <a:ext uri="{9D8B030D-6E8A-4147-A177-3AD203B41FA5}">
                      <a16:colId xmlns:a16="http://schemas.microsoft.com/office/drawing/2014/main" val="1310352641"/>
                    </a:ext>
                  </a:extLst>
                </a:gridCol>
                <a:gridCol w="1066148">
                  <a:extLst>
                    <a:ext uri="{9D8B030D-6E8A-4147-A177-3AD203B41FA5}">
                      <a16:colId xmlns:a16="http://schemas.microsoft.com/office/drawing/2014/main" val="3092741989"/>
                    </a:ext>
                  </a:extLst>
                </a:gridCol>
                <a:gridCol w="633768">
                  <a:extLst>
                    <a:ext uri="{9D8B030D-6E8A-4147-A177-3AD203B41FA5}">
                      <a16:colId xmlns:a16="http://schemas.microsoft.com/office/drawing/2014/main" val="3145270216"/>
                    </a:ext>
                  </a:extLst>
                </a:gridCol>
                <a:gridCol w="633768">
                  <a:extLst>
                    <a:ext uri="{9D8B030D-6E8A-4147-A177-3AD203B41FA5}">
                      <a16:colId xmlns:a16="http://schemas.microsoft.com/office/drawing/2014/main" val="2196969015"/>
                    </a:ext>
                  </a:extLst>
                </a:gridCol>
                <a:gridCol w="633768">
                  <a:extLst>
                    <a:ext uri="{9D8B030D-6E8A-4147-A177-3AD203B41FA5}">
                      <a16:colId xmlns:a16="http://schemas.microsoft.com/office/drawing/2014/main" val="3922923919"/>
                    </a:ext>
                  </a:extLst>
                </a:gridCol>
                <a:gridCol w="633768">
                  <a:extLst>
                    <a:ext uri="{9D8B030D-6E8A-4147-A177-3AD203B41FA5}">
                      <a16:colId xmlns:a16="http://schemas.microsoft.com/office/drawing/2014/main" val="2163699814"/>
                    </a:ext>
                  </a:extLst>
                </a:gridCol>
                <a:gridCol w="633768">
                  <a:extLst>
                    <a:ext uri="{9D8B030D-6E8A-4147-A177-3AD203B41FA5}">
                      <a16:colId xmlns:a16="http://schemas.microsoft.com/office/drawing/2014/main" val="862193874"/>
                    </a:ext>
                  </a:extLst>
                </a:gridCol>
                <a:gridCol w="633768">
                  <a:extLst>
                    <a:ext uri="{9D8B030D-6E8A-4147-A177-3AD203B41FA5}">
                      <a16:colId xmlns:a16="http://schemas.microsoft.com/office/drawing/2014/main" val="919506499"/>
                    </a:ext>
                  </a:extLst>
                </a:gridCol>
                <a:gridCol w="633768">
                  <a:extLst>
                    <a:ext uri="{9D8B030D-6E8A-4147-A177-3AD203B41FA5}">
                      <a16:colId xmlns:a16="http://schemas.microsoft.com/office/drawing/2014/main" val="751342568"/>
                    </a:ext>
                  </a:extLst>
                </a:gridCol>
                <a:gridCol w="633768">
                  <a:extLst>
                    <a:ext uri="{9D8B030D-6E8A-4147-A177-3AD203B41FA5}">
                      <a16:colId xmlns:a16="http://schemas.microsoft.com/office/drawing/2014/main" val="1510025752"/>
                    </a:ext>
                  </a:extLst>
                </a:gridCol>
                <a:gridCol w="633768">
                  <a:extLst>
                    <a:ext uri="{9D8B030D-6E8A-4147-A177-3AD203B41FA5}">
                      <a16:colId xmlns:a16="http://schemas.microsoft.com/office/drawing/2014/main" val="2187980825"/>
                    </a:ext>
                  </a:extLst>
                </a:gridCol>
                <a:gridCol w="633768">
                  <a:extLst>
                    <a:ext uri="{9D8B030D-6E8A-4147-A177-3AD203B41FA5}">
                      <a16:colId xmlns:a16="http://schemas.microsoft.com/office/drawing/2014/main" val="4095329497"/>
                    </a:ext>
                  </a:extLst>
                </a:gridCol>
                <a:gridCol w="633768">
                  <a:extLst>
                    <a:ext uri="{9D8B030D-6E8A-4147-A177-3AD203B41FA5}">
                      <a16:colId xmlns:a16="http://schemas.microsoft.com/office/drawing/2014/main" val="297631094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b="1" kern="0" spc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Type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 w="21590" cap="flat" cmpd="sng" algn="ctr">
                      <a:solidFill>
                        <a:srgbClr val="A0B4E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1590" cap="flat" cmpd="sng" algn="ctr">
                      <a:solidFill>
                        <a:srgbClr val="A0B4E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b="1" kern="0" spc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Region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 w="21590" cap="flat" cmpd="sng" algn="ctr">
                      <a:solidFill>
                        <a:srgbClr val="A0B4E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1590" cap="flat" cmpd="sng" algn="ctr">
                      <a:solidFill>
                        <a:srgbClr val="A0B4E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b="1" kern="0" spc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2012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 w="21590" cap="flat" cmpd="sng" algn="ctr">
                      <a:solidFill>
                        <a:srgbClr val="A0B4E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1590" cap="flat" cmpd="sng" algn="ctr">
                      <a:solidFill>
                        <a:srgbClr val="A0B4E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b="1" kern="0" spc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2013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 w="21590" cap="flat" cmpd="sng" algn="ctr">
                      <a:solidFill>
                        <a:srgbClr val="A0B4E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1590" cap="flat" cmpd="sng" algn="ctr">
                      <a:solidFill>
                        <a:srgbClr val="A0B4E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b="1" kern="0" spc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2014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 w="21590" cap="flat" cmpd="sng" algn="ctr">
                      <a:solidFill>
                        <a:srgbClr val="A0B4E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1590" cap="flat" cmpd="sng" algn="ctr">
                      <a:solidFill>
                        <a:srgbClr val="A0B4E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b="1" kern="0" spc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2015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 w="21590" cap="flat" cmpd="sng" algn="ctr">
                      <a:solidFill>
                        <a:srgbClr val="A0B4E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1590" cap="flat" cmpd="sng" algn="ctr">
                      <a:solidFill>
                        <a:srgbClr val="A0B4E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b="1" kern="0" spc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2016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 w="21590" cap="flat" cmpd="sng" algn="ctr">
                      <a:solidFill>
                        <a:srgbClr val="A0B4E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1590" cap="flat" cmpd="sng" algn="ctr">
                      <a:solidFill>
                        <a:srgbClr val="A0B4E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b="1" kern="0" spc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2017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 w="21590" cap="flat" cmpd="sng" algn="ctr">
                      <a:solidFill>
                        <a:srgbClr val="A0B4E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1590" cap="flat" cmpd="sng" algn="ctr">
                      <a:solidFill>
                        <a:srgbClr val="A0B4E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b="1" kern="0" spc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2018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 w="21590" cap="flat" cmpd="sng" algn="ctr">
                      <a:solidFill>
                        <a:srgbClr val="A0B4E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1590" cap="flat" cmpd="sng" algn="ctr">
                      <a:solidFill>
                        <a:srgbClr val="A0B4E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b="1" kern="0" spc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2019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 w="21590" cap="flat" cmpd="sng" algn="ctr">
                      <a:solidFill>
                        <a:srgbClr val="A0B4E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1590" cap="flat" cmpd="sng" algn="ctr">
                      <a:solidFill>
                        <a:srgbClr val="A0B4E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b="1" kern="0" spc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2020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 w="21590" cap="flat" cmpd="sng" algn="ctr">
                      <a:solidFill>
                        <a:srgbClr val="A0B4E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1590" cap="flat" cmpd="sng" algn="ctr">
                      <a:solidFill>
                        <a:srgbClr val="A0B4E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b="1" kern="0" spc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2021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 w="21590" cap="flat" cmpd="sng" algn="ctr">
                      <a:solidFill>
                        <a:srgbClr val="A0B4E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1590" cap="flat" cmpd="sng" algn="ctr">
                      <a:solidFill>
                        <a:srgbClr val="A0B4E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b="1" kern="0" spc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2022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 w="21590" cap="flat" cmpd="sng" algn="ctr">
                      <a:solidFill>
                        <a:srgbClr val="A0B4E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1590" cap="flat" cmpd="sng" algn="ctr">
                      <a:solidFill>
                        <a:srgbClr val="A0B4E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8466643"/>
                  </a:ext>
                </a:extLst>
              </a:tr>
              <a:tr h="411038">
                <a:tc rowSpan="5"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b="1" kern="0" spc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Paddy field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 w="21590" cap="flat" cmpd="sng" algn="ctr">
                      <a:solidFill>
                        <a:srgbClr val="A0B4E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b="1" kern="0" spc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Total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 w="21590" cap="flat" cmpd="sng" algn="ctr">
                      <a:solidFill>
                        <a:srgbClr val="A0B4E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966,076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 w="21590" cap="flat" cmpd="sng" algn="ctr">
                      <a:solidFill>
                        <a:srgbClr val="A0B4E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963,876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 w="21590" cap="flat" cmpd="sng" algn="ctr">
                      <a:solidFill>
                        <a:srgbClr val="A0B4E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933,615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 w="21590" cap="flat" cmpd="sng" algn="ctr">
                      <a:solidFill>
                        <a:srgbClr val="A0B4E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908,194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 w="21590" cap="flat" cmpd="sng" algn="ctr">
                      <a:solidFill>
                        <a:srgbClr val="A0B4E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895,739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 w="21590" cap="flat" cmpd="sng" algn="ctr">
                      <a:solidFill>
                        <a:srgbClr val="A0B4E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864,865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 w="21590" cap="flat" cmpd="sng" algn="ctr">
                      <a:solidFill>
                        <a:srgbClr val="A0B4E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844,265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 w="21590" cap="flat" cmpd="sng" algn="ctr">
                      <a:solidFill>
                        <a:srgbClr val="A0B4E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829,778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 w="21590" cap="flat" cmpd="sng" algn="ctr">
                      <a:solidFill>
                        <a:srgbClr val="A0B4E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823,895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 w="21590" cap="flat" cmpd="sng" algn="ctr">
                      <a:solidFill>
                        <a:srgbClr val="A0B4E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780,440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 w="21590" cap="flat" cmpd="sng" algn="ctr">
                      <a:solidFill>
                        <a:srgbClr val="A0B4E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775,640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 w="21590" cap="flat" cmpd="sng" algn="ctr">
                      <a:solidFill>
                        <a:srgbClr val="A0B4E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06726777"/>
                  </a:ext>
                </a:extLst>
              </a:tr>
              <a:tr h="411038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b="1" kern="0" spc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Deajeon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 dirty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1944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 dirty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1837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 dirty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1629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 dirty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1606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 dirty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1544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 dirty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1458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 dirty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1400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 dirty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1358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 dirty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1286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 dirty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1137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 dirty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1104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07429581"/>
                  </a:ext>
                </a:extLst>
              </a:tr>
              <a:tr h="411038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b="1" kern="0" spc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Sejong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-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 dirty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5508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 dirty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4968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 dirty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4785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 dirty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4616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 dirty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4513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 dirty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4387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 dirty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4250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 dirty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4241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 dirty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3704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 dirty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3526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38815029"/>
                  </a:ext>
                </a:extLst>
              </a:tr>
              <a:tr h="411038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b="1" kern="0" spc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Chungnam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49,443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48,062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45,164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44,541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43,807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40,506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38,613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38,290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37,970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35,349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35,134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50444737"/>
                  </a:ext>
                </a:extLst>
              </a:tr>
              <a:tr h="411038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b="1" kern="0" spc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Chungbuk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167,068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159,612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154,535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152,677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 dirty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151,431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148,558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146,703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145,785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145,103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141,925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141,674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92358102"/>
                  </a:ext>
                </a:extLst>
              </a:tr>
              <a:tr h="411038">
                <a:tc rowSpan="5"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b="1" kern="0" spc="0" dirty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Field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1590" cap="flat" cmpd="sng" algn="ctr">
                      <a:solidFill>
                        <a:srgbClr val="A0B4E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b="1" kern="0" spc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Total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763,905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747,560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757,498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770,829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747,860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755,931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751,349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751,179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740,902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766,277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752,597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C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58948281"/>
                  </a:ext>
                </a:extLst>
              </a:tr>
              <a:tr h="411038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b="1" kern="0" spc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Deajeon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 dirty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2877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 dirty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2779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 dirty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2755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 dirty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2699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 dirty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2528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 dirty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2430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 dirty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2394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 dirty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2384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 dirty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2292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 dirty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2824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 dirty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2754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C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76355637"/>
                  </a:ext>
                </a:extLst>
              </a:tr>
              <a:tr h="411038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b="1" kern="0" spc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Sejong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-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 dirty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4808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 dirty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3476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 dirty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3475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 dirty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3486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 dirty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3445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 dirty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3317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 dirty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3338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 dirty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3314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 dirty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3654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 dirty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3494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C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71986744"/>
                  </a:ext>
                </a:extLst>
              </a:tr>
              <a:tr h="411038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b="1" kern="0" spc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Chungnam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68,275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66,468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66,933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67,027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65,354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66,591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64,257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63,610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62,910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62,692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60,968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4FC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69497365"/>
                  </a:ext>
                </a:extLst>
              </a:tr>
              <a:tr h="411038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b="1" kern="0" spc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Chungbuk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1590" cap="flat" cmpd="sng" algn="ctr">
                      <a:solidFill>
                        <a:srgbClr val="A0B4E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67,558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1590" cap="flat" cmpd="sng" algn="ctr">
                      <a:solidFill>
                        <a:srgbClr val="A0B4E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65,017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1590" cap="flat" cmpd="sng" algn="ctr">
                      <a:solidFill>
                        <a:srgbClr val="A0B4E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64,680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1590" cap="flat" cmpd="sng" algn="ctr">
                      <a:solidFill>
                        <a:srgbClr val="A0B4E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66,110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1590" cap="flat" cmpd="sng" algn="ctr">
                      <a:solidFill>
                        <a:srgbClr val="A0B4E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63,669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1590" cap="flat" cmpd="sng" algn="ctr">
                      <a:solidFill>
                        <a:srgbClr val="A0B4E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64,680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1590" cap="flat" cmpd="sng" algn="ctr">
                      <a:solidFill>
                        <a:srgbClr val="A0B4E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64,874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1590" cap="flat" cmpd="sng" algn="ctr">
                      <a:solidFill>
                        <a:srgbClr val="A0B4E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64,644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1590" cap="flat" cmpd="sng" algn="ctr">
                      <a:solidFill>
                        <a:srgbClr val="A0B4E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63,528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1590" cap="flat" cmpd="sng" algn="ctr">
                      <a:solidFill>
                        <a:srgbClr val="A0B4E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75,501</a:t>
                      </a:r>
                      <a:endParaRPr lang="en-US" sz="1200" kern="0" spc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1590" cap="flat" cmpd="sng" algn="ctr">
                      <a:solidFill>
                        <a:srgbClr val="A0B4E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FCEB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fontAlgn="ctr" latinLnBrk="0">
                        <a:lnSpc>
                          <a:spcPct val="16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50" kern="0" spc="0" dirty="0">
                          <a:solidFill>
                            <a:srgbClr val="000000"/>
                          </a:solidFill>
                          <a:effectLst/>
                          <a:highlight>
                            <a:srgbClr val="F4FCEB"/>
                          </a:highlight>
                          <a:latin typeface="함초롬바탕" panose="02030604000101010101" pitchFamily="18" charset="-127"/>
                          <a:ea typeface="함초롬바탕" panose="02030604000101010101" pitchFamily="18" charset="-127"/>
                        </a:rPr>
                        <a:t>74,018</a:t>
                      </a:r>
                      <a:endParaRPr lang="en-US" sz="1200" kern="0" spc="0" dirty="0">
                        <a:solidFill>
                          <a:srgbClr val="000000"/>
                        </a:solidFill>
                        <a:effectLst/>
                        <a:highlight>
                          <a:srgbClr val="F4FCEB"/>
                        </a:highlight>
                        <a:latin typeface="맑은 고딕" panose="020B0503020000020004" pitchFamily="50" charset="-127"/>
                      </a:endParaRPr>
                    </a:p>
                  </a:txBody>
                  <a:tcPr marL="70869" marR="70869" marT="35434" marB="35434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1590" cap="flat" cmpd="sng" algn="ctr">
                      <a:solidFill>
                        <a:srgbClr val="A0B4E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FC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18774108"/>
                  </a:ext>
                </a:extLst>
              </a:tr>
            </a:tbl>
          </a:graphicData>
        </a:graphic>
      </p:graphicFrame>
      <p:sp>
        <p:nvSpPr>
          <p:cNvPr id="9" name="Rectangle 2">
            <a:extLst>
              <a:ext uri="{FF2B5EF4-FFF2-40B4-BE49-F238E27FC236}">
                <a16:creationId xmlns:a16="http://schemas.microsoft.com/office/drawing/2014/main" id="{3C9319ED-EBB8-7B26-314B-B0F2ADD74CE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5833" y="332994"/>
            <a:ext cx="6474849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함초롬바탕" panose="02030604000101010101" pitchFamily="18" charset="-127"/>
                <a:ea typeface="함초롬바탕" panose="02030604000101010101" pitchFamily="18" charset="-127"/>
              </a:rPr>
              <a:t>Table S1. Change in the land of agricultural land(2012-2022)(ha:10,000m</a:t>
            </a:r>
            <a:r>
              <a:rPr kumimoji="0" lang="en-US" altLang="ko-KR" sz="1400" b="1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함초롬바탕" panose="02030604000101010101" pitchFamily="18" charset="-127"/>
                <a:ea typeface="함초롬바탕" panose="02030604000101010101" pitchFamily="18" charset="-127"/>
              </a:rPr>
              <a:t>2</a:t>
            </a:r>
            <a:r>
              <a:rPr kumimoji="0" lang="en-US" altLang="ko-KR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함초롬바탕" panose="02030604000101010101" pitchFamily="18" charset="-127"/>
                <a:ea typeface="함초롬바탕" panose="02030604000101010101" pitchFamily="18" charset="-127"/>
              </a:rPr>
              <a:t>)</a:t>
            </a:r>
            <a:endParaRPr kumimoji="0" lang="en-US" altLang="ko-KR" sz="9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11111065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71</Words>
  <Application>Microsoft Office PowerPoint</Application>
  <PresentationFormat>Widescreen</PresentationFormat>
  <Paragraphs>138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맑은 고딕</vt:lpstr>
      <vt:lpstr>함초롬바탕</vt:lpstr>
      <vt:lpstr>Arial</vt:lpstr>
      <vt:lpstr>Office 테마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성찬 양</dc:creator>
  <cp:lastModifiedBy>MDPI</cp:lastModifiedBy>
  <cp:revision>2</cp:revision>
  <dcterms:created xsi:type="dcterms:W3CDTF">2024-06-25T12:25:48Z</dcterms:created>
  <dcterms:modified xsi:type="dcterms:W3CDTF">2024-07-11T05:14:18Z</dcterms:modified>
</cp:coreProperties>
</file>